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81"/>
  </p:normalViewPr>
  <p:slideViewPr>
    <p:cSldViewPr snapToGrid="0">
      <p:cViewPr varScale="1">
        <p:scale>
          <a:sx n="80" d="100"/>
          <a:sy n="80" d="100"/>
        </p:scale>
        <p:origin x="30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8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11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585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37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0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288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85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1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10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5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50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ECC40-4C37-4AAB-B992-398C5862C12D}" type="datetimeFigureOut">
              <a:rPr kumimoji="1" lang="ja-JP" altLang="en-US" smtClean="0"/>
              <a:t>2025/11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726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ED0ABC2-2F35-D02A-7B3C-B5B1E69E7943}"/>
              </a:ext>
            </a:extLst>
          </p:cNvPr>
          <p:cNvSpPr txBox="1"/>
          <p:nvPr/>
        </p:nvSpPr>
        <p:spPr>
          <a:xfrm>
            <a:off x="549000" y="6642333"/>
            <a:ext cx="5760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ibution of angiotensin II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ignal on cellular metabolic activity in bladder cancer cells. (A) Time course of oxygen consumption rate (OCR, upper panel) and extracellular acidification rates (ECAR, lower panel) in wild-type T24 cells treated with (+) or without (-) 10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timing of injecting oligomycin (Oligo), p-trifluoromethoxy carbonyl cyanide phenylhydrazone (FCCP), and rotenone is indicated. (B) Maximum (Max) and basal OCR (upper panels) and ECAR (lower panels) with or without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imulation. Data are presented as mean ± standard error of the mean (SEM) of OCR and ECAR. *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 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 0.05, by Welch’s t-test. ns: not significant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9874690A-8A20-C35D-EBA3-A5424710F6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000" y="1696544"/>
            <a:ext cx="5760000" cy="39527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707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39</Words>
  <Application>Microsoft Macintosh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神沼　修</dc:creator>
  <cp:lastModifiedBy>山中　亮憲</cp:lastModifiedBy>
  <cp:revision>5</cp:revision>
  <dcterms:created xsi:type="dcterms:W3CDTF">2025-07-04T02:55:30Z</dcterms:created>
  <dcterms:modified xsi:type="dcterms:W3CDTF">2025-11-18T06:59:05Z</dcterms:modified>
</cp:coreProperties>
</file>